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autoCompressPictures="0" strictFirstAndLastChars="0" saveSubsetFonts="1">
  <p:sldMasterIdLst>
    <p:sldMasterId id="2147483659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/>
</file>

<file path=ppt/tableStyles.xml><?xml version="1.0" encoding="utf-8"?>
<a:tblStyleLst xmlns:a="http://schemas.openxmlformats.org/drawingml/2006/main" xmlns:r="http://schemas.openxmlformats.org/officeDocument/2006/relationships" def="{AB604A86-737A-4838-9927-C67AEF05C7BE}">
  <a:tblStyle styleId="{AB604A86-737A-4838-9927-C67AEF05C7BE}" styleName="Table_0">
    <a:wholeTbl>
      <a:tcTxStyle>
        <a:font>
          <a:latin typeface="Calibri"/>
          <a:ea typeface="Calibri"/>
          <a:cs typeface="Calibri"/>
        </a:font>
        <a:srgbClr val="000000"/>
      </a:tcTxStyle>
      <a:tcStyle>
        <a:tcBdr>
          <a:left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insideV>
        </a:tcBdr>
      </a:tc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/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/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/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Google Shape;54;p13"/>
          <p:cNvGraphicFramePr/>
          <p:nvPr/>
        </p:nvGraphicFramePr>
        <p:xfrm>
          <a:off x="341325" y="610080"/>
          <a:ext cx="3000000" cy="3000000"/>
        </p:xfrm>
        <a:graphic>
          <a:graphicData uri="http://schemas.openxmlformats.org/drawingml/2006/table">
            <a:tbl>
              <a:tblPr bandRow="1">
                <a:noFill/>
                <a:tableStyleId>{AB604A86-737A-4838-9927-C67AEF05C7BE}</a:tableStyleId>
              </a:tblPr>
              <a:tblGrid>
                <a:gridCol w="6279725"/>
              </a:tblGrid>
              <a:tr h="129725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Baycrest Centre</a:t>
                      </a:r>
                      <a:r>
                        <a:rPr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arol Greenwood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Bruyère Research Institut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Stephanie Yamin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entre for Diagnosis and Research on Alzheimer’s Disease (CEDRA)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Ziad Nasreddine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entre Hospitalier de l’Université de </a:t>
                      </a: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ontréal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Josée Filion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ognitive Clinical Trials Group, Parkwood Institute</a:t>
                      </a:r>
                      <a:r>
                        <a:rPr baseline="30000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ichael Borrie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ognitive Neurology and Alzheimer’s Research Centr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Elizabeth Finger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Douglas Mental Health University Institute, Memory Clinic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N. V. P. Nair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Gait and Brain Lab, Parkwood Institut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Manuel Montero Odasso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Hamilton Health Sciences Centr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James Sahlas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Hôpital Enfant-Jésus (CHA)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Louis Verret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Jewish General Hospital Memory Clinic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Howard Chertkow</a:t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Kawartha Regional Memory Clinic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Jenny Ingram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London Health Sciences Centre, University Hospital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Vladimir Hachinski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cGill Centre for Studies in Aging</a:t>
                      </a:r>
                      <a:r>
                        <a:rPr b="1" baseline="30000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erge Gauthier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cGill University Hospital Centr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Ron Postuma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ontreal Neurological Institut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Simon Ducharme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95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entre de recherche sur le vieillissement, Institut universitaire de gériatrie de Sherbrooke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Tamas Fulop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Royal University Hospital</a:t>
                      </a:r>
                      <a:r>
                        <a:rPr b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ndrew Kirk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t. Joseph's Hospital</a:t>
                      </a:r>
                      <a:r>
                        <a:rPr b="1" baseline="30000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baseline="30000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amela Jarrett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he Centre for Memory and Aging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Giovanni Marotta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he Odette Memory Clinical Trials Unit </a:t>
                      </a:r>
                      <a:r>
                        <a:rPr b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andra Black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oronto Memory Program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Sharon Cohen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BC Centre for Brain Health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Ging-Yuek Robin Hsiung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niversity Health Network Memory Clinic </a:t>
                      </a:r>
                      <a:r>
                        <a:rPr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Ron Keren 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niversity of Alberta</a:t>
                      </a:r>
                      <a:r>
                        <a:rPr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Richard Camicioli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niversity of Calgary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Eric Smith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niversity of Northern British Columbia</a:t>
                      </a:r>
                      <a:r>
                        <a:rPr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Jacqueline Pettersen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University of Waterloo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 Laura Middleton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ancouver General Hospital</a:t>
                      </a:r>
                      <a:r>
                        <a:rPr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Teresa Liu-Ambrose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ancouver Island Health Authority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Alexandre Henri-Bhargava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62150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lnSpc>
                          <a:spcPct val="114000"/>
                        </a:lnSpc>
                        <a:spcBef>
                          <a:spcPts val="15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1"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Wilfrid Laurier University</a:t>
                      </a:r>
                      <a:r>
                        <a:rPr lang="en" sz="11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 Quincy Almeida</a:t>
                      </a:r>
                      <a:endParaRPr i="1"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9725">
                <a:tc>
                  <a:txBody>
                    <a:bodyPr>
                      <a:noAutofit/>
                    </a:bodyPr>
                    <a:lstStyle/>
                    <a:p>
                      <a:pPr indent="0" lvl="0" marL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1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0" marB="0" marR="68575" marL="68575">
                    <a:lnL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</a:tcPr>
                </a:tc>
              </a:tr>
            </a:tbl>
          </a:graphicData>
        </a:graphic>
      </p:graphicFrame>
      <p:sp>
        <p:nvSpPr>
          <p:cNvPr id="55" name="Google Shape;55;p13"/>
          <p:cNvSpPr txBox="1"/>
          <p:nvPr/>
        </p:nvSpPr>
        <p:spPr>
          <a:xfrm>
            <a:off x="613925" y="167425"/>
            <a:ext cx="3000000" cy="3873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latin typeface="Times New Roman"/>
                <a:ea typeface="Times New Roman"/>
                <a:cs typeface="Times New Roman"/>
                <a:sym typeface="Times New Roman"/>
              </a:rPr>
              <a:t>Appendix 2 - CCNA data collection sites</a:t>
            </a:r>
            <a:endParaRPr b="1" sz="1200"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